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2" d="100"/>
          <a:sy n="82" d="100"/>
        </p:scale>
        <p:origin x="691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E3C0C7-1ECB-416F-996B-941237F2EB0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94E3A2D-CFF3-4534-BBD9-A0E5FF26011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3457C3-BFF0-4A00-8682-8BE3ECEBF3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6E94A-06BD-4136-B812-E3B0F8464521}" type="datetimeFigureOut">
              <a:rPr lang="en-US" smtClean="0"/>
              <a:t>7/2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F7AF13-26B0-4431-99CB-E47F72F96F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9CA33B-864F-4666-AA89-CA86F86184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36724-6E80-405F-8E52-4959E67E36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74103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DF9033-C424-409B-A586-F7AE82C47E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98609C7-3D65-4904-A09A-8B2CB15841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1127D3-0FF8-439B-A436-AC0F73004E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6E94A-06BD-4136-B812-E3B0F8464521}" type="datetimeFigureOut">
              <a:rPr lang="en-US" smtClean="0"/>
              <a:t>7/2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189247-CE3F-4B32-BC8C-982CCC99E7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BC72E6-0B02-4F9D-91E3-F8C15CCCB4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36724-6E80-405F-8E52-4959E67E36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96593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AD5C832-E542-4FE3-BD73-43EC6427F54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0D59379-E5F1-4170-ADEF-C93995EC9F7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E93702-C4F7-4010-A632-C62C4A98E2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6E94A-06BD-4136-B812-E3B0F8464521}" type="datetimeFigureOut">
              <a:rPr lang="en-US" smtClean="0"/>
              <a:t>7/2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326953-D61E-47CB-A33B-EFC37B1E41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66921C-0654-4F38-8E04-1D28CB4DC5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36724-6E80-405F-8E52-4959E67E36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03166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16FFF4-012D-4801-BEF8-E304F30D45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ABA9428-7173-4298-8CAE-5EF55E6EF17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E7D7D1-8A0E-43B3-98D0-1EBD100F46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6E94A-06BD-4136-B812-E3B0F8464521}" type="datetimeFigureOut">
              <a:rPr lang="en-US" smtClean="0"/>
              <a:t>7/2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DAFE7C-F7EA-4810-A148-9C9B9AF28C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EF0893-3E81-4526-A4C3-6904197403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36724-6E80-405F-8E52-4959E67E36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70527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EFDC75-1BB7-4935-BCF8-CAB5B94814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E98B914-C17B-42A6-B710-15FE9EACD1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3C7FD8-8238-4959-85D4-FD219017F7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6E94A-06BD-4136-B812-E3B0F8464521}" type="datetimeFigureOut">
              <a:rPr lang="en-US" smtClean="0"/>
              <a:t>7/2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B668D0-4932-4A96-A837-486C07C627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8BD49D-1D91-48A2-9B25-5973B2D1C0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36724-6E80-405F-8E52-4959E67E36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67255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31FD25-DD13-4C57-94D5-5D8630A87A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F4DEFBF-E9A2-4767-9D74-CE0901D9D6A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2FFBCBC-72AA-4AE8-8650-AA7E89B16E8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7D996A-8F05-4286-868E-181C4714D6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6E94A-06BD-4136-B812-E3B0F8464521}" type="datetimeFigureOut">
              <a:rPr lang="en-US" smtClean="0"/>
              <a:t>7/20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2EB0FB0-0466-4DB0-87F2-0A9D4D8414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37DE2D8-5A0E-40C8-A039-EEF666EA16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36724-6E80-405F-8E52-4959E67E36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6706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F2EC3E-7AC1-4AED-B769-C24A73F7DB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E41E868-6DEF-48F3-A0F8-C74B6408E5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0D8621B-AA26-4D3D-AB9D-DBA062FE983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BABFE1D-1ED5-4FA9-9FF5-618FB751C16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E902FD7-0EC8-4798-8BF8-CC9EE305766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6878123-FD95-4DC7-A756-2E24ABCC67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6E94A-06BD-4136-B812-E3B0F8464521}" type="datetimeFigureOut">
              <a:rPr lang="en-US" smtClean="0"/>
              <a:t>7/20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A475723-4DE5-4979-BF54-F4D7B86A75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853566D-B442-4EC8-B607-537BEEFC85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36724-6E80-405F-8E52-4959E67E36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09113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421527-87C7-4684-A198-6E75757556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551DCEF-6BCA-4D00-B9E2-8BAC3DB611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6E94A-06BD-4136-B812-E3B0F8464521}" type="datetimeFigureOut">
              <a:rPr lang="en-US" smtClean="0"/>
              <a:t>7/20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9CE4BEC-CA06-4597-BE3E-6537152E6F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7136008-65DB-42B9-A32D-74735521CE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36724-6E80-405F-8E52-4959E67E36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3024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B606645-7784-4F3E-BBAE-B7148876CB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6E94A-06BD-4136-B812-E3B0F8464521}" type="datetimeFigureOut">
              <a:rPr lang="en-US" smtClean="0"/>
              <a:t>7/20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DDCC2AB-97B6-43DF-BE10-7E1409C9C7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4FB4216-233D-4D3C-9D4C-A82E87334E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36724-6E80-405F-8E52-4959E67E36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34977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9BD6C2-39A7-482A-A988-AF1407C49B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860D19-3F0F-441B-9596-6D54888E9E6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C5B4DAE-17AD-4C7F-990C-29FBF3AEA5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CF2EA6-7E6E-4D3C-8D1A-C0EB706624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6E94A-06BD-4136-B812-E3B0F8464521}" type="datetimeFigureOut">
              <a:rPr lang="en-US" smtClean="0"/>
              <a:t>7/20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4771D2F-0DC6-411E-9D72-B43318B569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297659D-9471-4E17-96C2-7BE62F724D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36724-6E80-405F-8E52-4959E67E36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72028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B568F7-ABAA-469A-B0F7-963BC3260A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EBFEB4F-0533-4A4C-AE02-827E7F740C3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0D267DF-B31E-4A53-9D63-B9ABBD338A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5927709-FA0E-45B7-A121-3C930320E5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6E94A-06BD-4136-B812-E3B0F8464521}" type="datetimeFigureOut">
              <a:rPr lang="en-US" smtClean="0"/>
              <a:t>7/20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9461A77-F943-46C2-9367-C5B372C682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AAA76F3-088B-4949-B15D-897FF2B58E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36724-6E80-405F-8E52-4959E67E36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24649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5E5A12A-AA0C-40A9-9A5E-B91EEC5DD9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FA0CF22-7C7A-4C9D-BF41-C5BBBB8C8E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91F220-32C1-4148-AADF-A45AECE4B5E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06E94A-06BD-4136-B812-E3B0F8464521}" type="datetimeFigureOut">
              <a:rPr lang="en-US" smtClean="0"/>
              <a:t>7/2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9C75B9-91F9-4351-A031-A1877350487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99611A-42F3-4F13-A022-9029E66314E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736724-6E80-405F-8E52-4959E67E36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26005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52CFB6F-4BED-4645-89EE-7562F93CA0D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59216" y="1492898"/>
            <a:ext cx="4932784" cy="499161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45C5E9B1-5753-402E-B81B-673C228001F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0546" y="972061"/>
            <a:ext cx="6755363" cy="574133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84F21B0-4521-46D3-8BE5-1D81909275D2}"/>
              </a:ext>
            </a:extLst>
          </p:cNvPr>
          <p:cNvSpPr txBox="1"/>
          <p:nvPr/>
        </p:nvSpPr>
        <p:spPr>
          <a:xfrm>
            <a:off x="0" y="0"/>
            <a:ext cx="12193554" cy="97206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ry Figure 2</a:t>
            </a:r>
            <a:endParaRPr lang="en-US" sz="12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rincipal component analysis of acidic pI proteins. The PCA plot shows the pI of virus protein originated from host algae, archaea, invertebrate, protozoa, and vertebrate clustered together whereas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I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of virus protein of host bacteria and humans fall distantly. Heatmap shows the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I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of all the virus protein originated from different host shows positive correlation. The heat map was generated using JAPS software version 0.14.1.0.</a:t>
            </a:r>
          </a:p>
        </p:txBody>
      </p:sp>
    </p:spTree>
    <p:extLst>
      <p:ext uri="{BB962C8B-B14F-4D97-AF65-F5344CB8AC3E}">
        <p14:creationId xmlns:p14="http://schemas.microsoft.com/office/powerpoint/2010/main" val="24746214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76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hanta Tapan</dc:creator>
  <cp:lastModifiedBy>HP</cp:lastModifiedBy>
  <cp:revision>6</cp:revision>
  <dcterms:created xsi:type="dcterms:W3CDTF">2021-04-07T06:09:52Z</dcterms:created>
  <dcterms:modified xsi:type="dcterms:W3CDTF">2021-07-20T04:49:48Z</dcterms:modified>
</cp:coreProperties>
</file>